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CC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142" autoAdjust="0"/>
  </p:normalViewPr>
  <p:slideViewPr>
    <p:cSldViewPr>
      <p:cViewPr>
        <p:scale>
          <a:sx n="100" d="100"/>
          <a:sy n="100" d="100"/>
        </p:scale>
        <p:origin x="-110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759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834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275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623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184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670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857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632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161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32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350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A3B64-E984-4129-83A4-9F0DFF6992E4}" type="datetimeFigureOut">
              <a:rPr lang="en-US" smtClean="0"/>
              <a:t>5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8E1AE-B992-4974-91D0-B0A8DDC19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954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295400" y="4593267"/>
            <a:ext cx="2238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remier Russet_PVY-O_10h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019800" y="1447800"/>
            <a:ext cx="21474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remier Russet_PVY-O_4h</a:t>
            </a:r>
            <a:endParaRPr lang="en-US" sz="14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1993890" y="6412468"/>
            <a:ext cx="51562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7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quare of coefficient of variation</a:t>
            </a:r>
          </a:p>
        </p:txBody>
      </p:sp>
      <p:pic>
        <p:nvPicPr>
          <p:cNvPr id="37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152400"/>
            <a:ext cx="5534829" cy="304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2350" y="3276600"/>
            <a:ext cx="5479482" cy="3017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755918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993890" y="6412468"/>
            <a:ext cx="51562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7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quare of coefficient of variatio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295400" y="4593267"/>
            <a:ext cx="24424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remier Russet_PVY-NTN_10h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019800" y="1447800"/>
            <a:ext cx="2351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remier Russet_PVY-NTN_4h</a:t>
            </a:r>
            <a:endParaRPr lang="en-US" sz="1400" b="1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76200"/>
            <a:ext cx="5479480" cy="3017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4521" y="3276600"/>
            <a:ext cx="5479479" cy="3017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16527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11731" y="4648200"/>
            <a:ext cx="22744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Russet Burbank_PVY-O_10h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486400" y="1673423"/>
            <a:ext cx="21830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Russet Burbank_PVY-O_4h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993890" y="6412468"/>
            <a:ext cx="51562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7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quare of coefficient of variation</a:t>
            </a: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005"/>
          <a:stretch/>
        </p:blipFill>
        <p:spPr bwMode="auto">
          <a:xfrm>
            <a:off x="76200" y="335280"/>
            <a:ext cx="4986060" cy="3017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25"/>
          <a:stretch/>
        </p:blipFill>
        <p:spPr bwMode="auto">
          <a:xfrm>
            <a:off x="4038600" y="3383280"/>
            <a:ext cx="4990455" cy="3017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082977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457200"/>
            <a:ext cx="5479479" cy="3017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5867400" y="1812071"/>
            <a:ext cx="29598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remier Russet &amp; Russet Burbank_0h</a:t>
            </a:r>
            <a:endParaRPr lang="en-US" sz="14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993890" y="6412468"/>
            <a:ext cx="51562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7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quare of coefficient of variation</a:t>
            </a:r>
          </a:p>
        </p:txBody>
      </p:sp>
    </p:spTree>
    <p:extLst>
      <p:ext uri="{BB962C8B-B14F-4D97-AF65-F5344CB8AC3E}">
        <p14:creationId xmlns:p14="http://schemas.microsoft.com/office/powerpoint/2010/main" val="3616870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4</TotalTime>
  <Words>53</Words>
  <Application>Microsoft Office PowerPoint</Application>
  <PresentationFormat>On-screen Show (4:3)</PresentationFormat>
  <Paragraphs>1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pport</dc:creator>
  <cp:lastModifiedBy>Support</cp:lastModifiedBy>
  <cp:revision>71</cp:revision>
  <dcterms:created xsi:type="dcterms:W3CDTF">2015-03-13T05:07:09Z</dcterms:created>
  <dcterms:modified xsi:type="dcterms:W3CDTF">2015-05-14T17:01:03Z</dcterms:modified>
</cp:coreProperties>
</file>